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3" r:id="rId2"/>
    <p:sldId id="270" r:id="rId3"/>
    <p:sldId id="256" r:id="rId4"/>
    <p:sldId id="271" r:id="rId5"/>
    <p:sldId id="260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271"/>
  </p:normalViewPr>
  <p:slideViewPr>
    <p:cSldViewPr snapToGrid="0" snapToObjects="1">
      <p:cViewPr varScale="1">
        <p:scale>
          <a:sx n="98" d="100"/>
          <a:sy n="98" d="100"/>
        </p:scale>
        <p:origin x="5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9F165B1-6EEE-B64B-A177-D60B29DDF2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A1473023-9669-7948-B890-C6D63E8137B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AB5BAC9-AEE9-3F4A-B073-A53BF8DE7F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72257-5404-1D44-B007-B17346D45AD3}" type="datetimeFigureOut">
              <a:rPr lang="de-DE" smtClean="0"/>
              <a:t>27.05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777C322-29F2-FA4E-9B1C-86A8E5554D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E6870F5-D587-6B4A-AE23-A7D8CEC58E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925F7-A56D-A947-A767-211F0CAE97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9159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E4E0ADF-E14F-4549-82CA-6D213997CC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7750832-4B0E-E049-8A1C-21EEF5FD46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DAD8364-B54B-F24D-BE92-35FC12298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72257-5404-1D44-B007-B17346D45AD3}" type="datetimeFigureOut">
              <a:rPr lang="de-DE" smtClean="0"/>
              <a:t>27.05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3A2C9D2-4263-5E42-AE16-F55E21BD57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1582BF3-F68D-654D-BEFD-856C38F4B9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925F7-A56D-A947-A767-211F0CAE97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7758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598EDE8D-838B-D542-BB1A-2301F2AE9D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DDE61A9-A72E-2B45-A901-23857F5652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569F40B-C186-A04F-80F8-A3466CF13B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72257-5404-1D44-B007-B17346D45AD3}" type="datetimeFigureOut">
              <a:rPr lang="de-DE" smtClean="0"/>
              <a:t>27.05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8321971-4BF6-D748-9D50-90C96503F8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CF88B57-7F22-AB49-961A-FB827F3CF8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925F7-A56D-A947-A767-211F0CAE97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67909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38B5E9A-C6AF-FC40-98D8-108BABF898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26C01DF-4484-0247-B730-139D593B6A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2A82D23-676A-D440-9BF9-0D9832212F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72257-5404-1D44-B007-B17346D45AD3}" type="datetimeFigureOut">
              <a:rPr lang="de-DE" smtClean="0"/>
              <a:t>27.05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FB84999-070E-3147-9AE7-0D859FFD4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83B2E58-60C5-964A-80E8-11BE5F37ED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925F7-A56D-A947-A767-211F0CAE97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1136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A94AD05-B847-4F4E-9600-41E080D91D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46A0375-6C53-0E4D-98B9-825E49C446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0811A18-75E5-8748-82F2-895011AA0D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72257-5404-1D44-B007-B17346D45AD3}" type="datetimeFigureOut">
              <a:rPr lang="de-DE" smtClean="0"/>
              <a:t>27.05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ED7E798-8612-0E40-A700-A2E44C363B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31AC2D6-37FA-444A-B5BE-20C68BEFD4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925F7-A56D-A947-A767-211F0CAE97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19757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9476F59-A147-AF4F-A8E3-B90D2C353C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8DD6F2E-F3C4-B940-8BB4-5BC7BB1B7A6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E7FB3BF-4C40-BF45-B651-264F6FA87A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4CE6AF2-129B-C542-ACBD-E9BAE725DF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72257-5404-1D44-B007-B17346D45AD3}" type="datetimeFigureOut">
              <a:rPr lang="de-DE" smtClean="0"/>
              <a:t>27.05.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8E355C5-6E23-7545-A66E-697617FAB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B8061EA-9698-0C45-83AC-AFA215ADCC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925F7-A56D-A947-A767-211F0CAE97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0574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6606A34-B4E4-5C48-AA6E-15A62521D8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D0EEFFA-019C-6F4E-A8DD-6ECAE8DD9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08742148-6D16-6D49-8C60-A0647723D8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C8AEA9E3-8F2D-3745-BF0D-1A6C977C99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93E30F0E-304E-FE4D-8575-0D121C7BD07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608456A-1844-5744-B28A-D2C7F4B3C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72257-5404-1D44-B007-B17346D45AD3}" type="datetimeFigureOut">
              <a:rPr lang="de-DE" smtClean="0"/>
              <a:t>27.05.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2B55783B-3AA7-9B43-97C0-781EF0EBD5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CEC5008A-FB5B-6143-B381-1989D4FECB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925F7-A56D-A947-A767-211F0CAE97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7915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B4F5ADF-CF9B-F24C-9356-E9D041B1F8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AB94BCF3-F6F5-2446-9CAB-C680F0699D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72257-5404-1D44-B007-B17346D45AD3}" type="datetimeFigureOut">
              <a:rPr lang="de-DE" smtClean="0"/>
              <a:t>27.05.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B9FF3E48-95A0-9548-8241-2A6B2B592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56E8C4C-CE12-084C-9175-E75E3BD30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925F7-A56D-A947-A767-211F0CAE97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2281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E5F060FF-A97C-EB4B-ACDC-3CCF97E228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72257-5404-1D44-B007-B17346D45AD3}" type="datetimeFigureOut">
              <a:rPr lang="de-DE" smtClean="0"/>
              <a:t>27.05.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3EE564D2-B37B-864F-92D6-F788CDBF6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D7DD728-5C71-4640-8209-3946B44980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925F7-A56D-A947-A767-211F0CAE97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9576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197EFB9-212D-8D4B-B29D-70BC2EF2D8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15DD6DD-F01C-F04A-A8CA-50350D63A1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CC6A2FE-F77C-4446-A700-3D81FA76FC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1016355-F1F2-EA4D-BF91-DB01E584A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72257-5404-1D44-B007-B17346D45AD3}" type="datetimeFigureOut">
              <a:rPr lang="de-DE" smtClean="0"/>
              <a:t>27.05.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198E20C-030D-F54F-8DD0-0BC8ED3F5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5B7CA61-9354-C941-9EEB-34E01DE0DF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925F7-A56D-A947-A767-211F0CAE97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579846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4E437C4-C90E-2F46-B149-7D9883E123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46514DA1-8C69-CF40-8D49-F88A9E5D58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DF23AF5-4E93-A543-91ED-7A1FF4ED76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2E87975-0FF4-8F42-8B0F-78AD4E3C6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72257-5404-1D44-B007-B17346D45AD3}" type="datetimeFigureOut">
              <a:rPr lang="de-DE" smtClean="0"/>
              <a:t>27.05.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B31EEAF-059E-BA49-A816-34991D987F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F92799F-343F-B442-95C3-AE18852317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925F7-A56D-A947-A767-211F0CAE97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31296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1024119A-E24E-6E4D-BC54-B99FB62E1C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153F245-DA41-8449-B9FF-A919F8FC33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5000E40-DD40-FD47-8061-C88BD9ABC8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472257-5404-1D44-B007-B17346D45AD3}" type="datetimeFigureOut">
              <a:rPr lang="de-DE" smtClean="0"/>
              <a:t>27.05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FF7B601-1D4A-4C4A-9C77-3FE18639CB6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7F0DF6D-8E5C-4F47-B32D-5E3F39679C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925F7-A56D-A947-A767-211F0CAE97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6773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7" Type="http://schemas.openxmlformats.org/officeDocument/2006/relationships/image" Target="../media/image7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eg"/><Relationship Id="rId5" Type="http://schemas.openxmlformats.org/officeDocument/2006/relationships/image" Target="../media/image5.png"/><Relationship Id="rId4" Type="http://schemas.openxmlformats.org/officeDocument/2006/relationships/image" Target="../media/image4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7230B291-7241-A862-4378-BCCBDF1761ED}"/>
              </a:ext>
            </a:extLst>
          </p:cNvPr>
          <p:cNvSpPr txBox="1"/>
          <p:nvPr/>
        </p:nvSpPr>
        <p:spPr>
          <a:xfrm>
            <a:off x="0" y="6488668"/>
            <a:ext cx="6100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b="1" dirty="0"/>
              <a:t>S1</a:t>
            </a:r>
            <a:endParaRPr lang="de-DE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66A18E71-65CB-DADD-3537-D242FC5FB2E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5928"/>
          <a:stretch/>
        </p:blipFill>
        <p:spPr>
          <a:xfrm>
            <a:off x="335280" y="415290"/>
            <a:ext cx="11521440" cy="60274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25581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3" name="Rechteck 2"/>
          <p:cNvSpPr/>
          <p:nvPr/>
        </p:nvSpPr>
        <p:spPr>
          <a:xfrm>
            <a:off x="759069" y="226769"/>
            <a:ext cx="10594731" cy="2927838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unPlugin('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upath.imagej.detect.cells.PositiveCellDetection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', '{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etectionImageBrightfield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ematoxylin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OD", 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equestedPixelSizeMicrons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0.5, 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backgroundRadiusMicrons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8.0, 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edianRadiusMicrons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0.0, 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igmaMicrons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2.2, 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inAreaMicrons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10.0, 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axAreaMicrons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600.0, 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hreshold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0.05, 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axBackground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2.0, 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watershedPostProcess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rue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, 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xcludeDAB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alse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, 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ellExpansionMicrons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5.0, 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ncludeNuclei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rue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, 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moothBoundaries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rue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, 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akeMeasurements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rue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, 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hresholdCompartment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"Nucleus: DAB OD 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ean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,  "thresholdPositive1": 0.75,  "thresholdPositive2": 0.4,  "thresholdPositive3": 0.6000000000000001,  "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ingleThreshold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": </a:t>
            </a:r>
            <a:r>
              <a:rPr lang="de-DE" err="1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rue</a:t>
            </a:r>
            <a:r>
              <a:rPr lang="de-DE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}');</a:t>
            </a:r>
          </a:p>
        </p:txBody>
      </p:sp>
      <p:sp>
        <p:nvSpPr>
          <p:cNvPr id="5" name="Rechteck 4"/>
          <p:cNvSpPr/>
          <p:nvPr/>
        </p:nvSpPr>
        <p:spPr>
          <a:xfrm>
            <a:off x="759069" y="3108297"/>
            <a:ext cx="8531629" cy="369332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r>
              <a:rPr lang="de-DE" b="1" dirty="0"/>
              <a:t>S2 A</a:t>
            </a:r>
            <a:r>
              <a:rPr lang="de-DE" dirty="0"/>
              <a:t> Th17  </a:t>
            </a:r>
            <a:r>
              <a:rPr lang="de-DE" dirty="0" err="1"/>
              <a:t>cell</a:t>
            </a:r>
            <a:r>
              <a:rPr lang="de-DE" dirty="0"/>
              <a:t> </a:t>
            </a:r>
            <a:r>
              <a:rPr lang="de-DE" dirty="0" err="1"/>
              <a:t>detection</a:t>
            </a:r>
            <a:r>
              <a:rPr lang="de-DE" dirty="0"/>
              <a:t> </a:t>
            </a:r>
            <a:r>
              <a:rPr lang="de-DE" dirty="0" err="1"/>
              <a:t>algorithm</a:t>
            </a:r>
            <a:r>
              <a:rPr lang="de-DE" dirty="0"/>
              <a:t> </a:t>
            </a:r>
            <a:r>
              <a:rPr lang="de-DE" dirty="0" err="1"/>
              <a:t>settings</a:t>
            </a:r>
            <a:r>
              <a:rPr lang="de-DE" dirty="0"/>
              <a:t>  </a:t>
            </a:r>
          </a:p>
        </p:txBody>
      </p:sp>
      <p:sp>
        <p:nvSpPr>
          <p:cNvPr id="6" name="Rechteck 5"/>
          <p:cNvSpPr/>
          <p:nvPr/>
        </p:nvSpPr>
        <p:spPr>
          <a:xfrm>
            <a:off x="674621" y="6499290"/>
            <a:ext cx="4216347" cy="369332"/>
          </a:xfrm>
          <a:prstGeom prst="rect">
            <a:avLst/>
          </a:prstGeom>
        </p:spPr>
        <p:txBody>
          <a:bodyPr wrap="none" lIns="91440" tIns="45720" rIns="91440" bIns="45720" anchor="t">
            <a:spAutoFit/>
          </a:bodyPr>
          <a:lstStyle/>
          <a:p>
            <a:r>
              <a:rPr lang="de-DE" b="1" dirty="0"/>
              <a:t>S2 B</a:t>
            </a:r>
            <a:r>
              <a:rPr lang="de-DE" dirty="0"/>
              <a:t> </a:t>
            </a:r>
            <a:r>
              <a:rPr lang="de-DE" dirty="0" err="1"/>
              <a:t>Treg</a:t>
            </a:r>
            <a:r>
              <a:rPr lang="de-DE" dirty="0"/>
              <a:t> </a:t>
            </a:r>
            <a:r>
              <a:rPr lang="de-DE" dirty="0" err="1"/>
              <a:t>cell</a:t>
            </a:r>
            <a:r>
              <a:rPr lang="de-DE" dirty="0"/>
              <a:t> </a:t>
            </a:r>
            <a:r>
              <a:rPr lang="de-DE" dirty="0" err="1"/>
              <a:t>detection</a:t>
            </a:r>
            <a:r>
              <a:rPr lang="de-DE" dirty="0"/>
              <a:t> </a:t>
            </a:r>
            <a:r>
              <a:rPr lang="de-DE" dirty="0" err="1"/>
              <a:t>algorithm</a:t>
            </a:r>
            <a:r>
              <a:rPr lang="de-DE" dirty="0"/>
              <a:t> </a:t>
            </a:r>
            <a:r>
              <a:rPr lang="de-DE" dirty="0" err="1"/>
              <a:t>settings</a:t>
            </a:r>
            <a:r>
              <a:rPr lang="de-DE" dirty="0"/>
              <a:t>  </a:t>
            </a:r>
            <a:endParaRPr lang="de-DE" dirty="0">
              <a:solidFill>
                <a:prstClr val="black"/>
              </a:solidFill>
            </a:endParaRPr>
          </a:p>
        </p:txBody>
      </p:sp>
      <p:sp>
        <p:nvSpPr>
          <p:cNvPr id="7" name="Rechteck 6"/>
          <p:cNvSpPr/>
          <p:nvPr/>
        </p:nvSpPr>
        <p:spPr>
          <a:xfrm>
            <a:off x="759069" y="3568823"/>
            <a:ext cx="10594731" cy="2930467"/>
          </a:xfrm>
          <a:prstGeom prst="rect">
            <a:avLst/>
          </a:prstGeom>
          <a:solidFill>
            <a:schemeClr val="bg1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runPlugin('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qupath.imagej.detect.cells.PositiveCellDetection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', '{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detectionImageBrightfield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Hematoxylin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 OD", 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requestedPixelSizeMicrons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0.5, 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backgroundRadiusMicrons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8.0, 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medianRadiusMicrons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0.0, 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sigmaMicrons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2.0, 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minAreaMicrons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10.0, 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maxAreaMicrons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400.0, 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threshold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0.1, 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maxBackground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2.0, 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watershedPostProcess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true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, 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excludeDAB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false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, 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cellExpansionMicrons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5.0, 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includeNuclei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true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, 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smoothBoundaries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true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, 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makeMeasurements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true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, 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thresholdCompartment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"Nucleus: DAB OD 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mean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,  "thresholdPositive1": 0.7,  "thresholdPositive2": 0.4,  "thresholdPositive3": 0.6000000000000001,  "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singleThreshold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": </a:t>
            </a:r>
            <a:r>
              <a:rPr lang="de-DE" err="1">
                <a:latin typeface="Courier New" panose="02070309020205020404" pitchFamily="49" charset="0"/>
                <a:cs typeface="Courier New" panose="02070309020205020404" pitchFamily="49" charset="0"/>
              </a:rPr>
              <a:t>true</a:t>
            </a:r>
            <a:r>
              <a:rPr lang="de-DE">
                <a:latin typeface="Courier New" panose="02070309020205020404" pitchFamily="49" charset="0"/>
                <a:cs typeface="Courier New" panose="02070309020205020404" pitchFamily="49" charset="0"/>
              </a:rPr>
              <a:t>}');</a:t>
            </a:r>
          </a:p>
        </p:txBody>
      </p:sp>
    </p:spTree>
    <p:extLst>
      <p:ext uri="{BB962C8B-B14F-4D97-AF65-F5344CB8AC3E}">
        <p14:creationId xmlns:p14="http://schemas.microsoft.com/office/powerpoint/2010/main" val="14337588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/>
        </p:nvGraphicFramePr>
        <p:xfrm>
          <a:off x="1860550" y="2153412"/>
          <a:ext cx="7556500" cy="110680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46200">
                  <a:extLst>
                    <a:ext uri="{9D8B030D-6E8A-4147-A177-3AD203B41FA5}">
                      <a16:colId xmlns:a16="http://schemas.microsoft.com/office/drawing/2014/main" val="1801157390"/>
                    </a:ext>
                  </a:extLst>
                </a:gridCol>
                <a:gridCol w="2057400">
                  <a:extLst>
                    <a:ext uri="{9D8B030D-6E8A-4147-A177-3AD203B41FA5}">
                      <a16:colId xmlns:a16="http://schemas.microsoft.com/office/drawing/2014/main" val="1900963139"/>
                    </a:ext>
                  </a:extLst>
                </a:gridCol>
                <a:gridCol w="2095500">
                  <a:extLst>
                    <a:ext uri="{9D8B030D-6E8A-4147-A177-3AD203B41FA5}">
                      <a16:colId xmlns:a16="http://schemas.microsoft.com/office/drawing/2014/main" val="3568528256"/>
                    </a:ext>
                  </a:extLst>
                </a:gridCol>
                <a:gridCol w="2057400">
                  <a:extLst>
                    <a:ext uri="{9D8B030D-6E8A-4147-A177-3AD203B41FA5}">
                      <a16:colId xmlns:a16="http://schemas.microsoft.com/office/drawing/2014/main" val="17971896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ICC first pathologist and </a:t>
                      </a:r>
                      <a:r>
                        <a:rPr lang="en-US" sz="1100" b="1" u="none" strike="noStrike" dirty="0" err="1">
                          <a:effectLst/>
                        </a:rPr>
                        <a:t>QuPath</a:t>
                      </a:r>
                      <a:r>
                        <a:rPr lang="en-US" sz="1100" b="1" u="none" strike="noStrike" dirty="0">
                          <a:effectLst/>
                        </a:rPr>
                        <a:t>*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ICC second pathologist and </a:t>
                      </a:r>
                      <a:r>
                        <a:rPr lang="en-US" sz="1100" b="1" u="none" strike="noStrike" dirty="0" err="1">
                          <a:effectLst/>
                        </a:rPr>
                        <a:t>QuPath</a:t>
                      </a:r>
                      <a:r>
                        <a:rPr lang="en-US" sz="1100" b="1" u="none" strike="noStrike" dirty="0">
                          <a:effectLst/>
                        </a:rPr>
                        <a:t>*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 ICC first and second Pathologist*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2779355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Tregs all cells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.81 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.6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.8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2652249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Tregs postive cells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.8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.9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.9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1462852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Th17 all cells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.8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.7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.8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2629524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Th17 positive cells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.7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.6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0.5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49578728"/>
                  </a:ext>
                </a:extLst>
              </a:tr>
            </a:tbl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1764792" y="3260217"/>
            <a:ext cx="3033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*ICC was </a:t>
            </a:r>
            <a:r>
              <a:rPr lang="de-DE" sz="1200" dirty="0" err="1"/>
              <a:t>computed</a:t>
            </a:r>
            <a:r>
              <a:rPr lang="de-DE" sz="1200" dirty="0"/>
              <a:t> </a:t>
            </a:r>
            <a:r>
              <a:rPr lang="de-DE" sz="1200" dirty="0" err="1"/>
              <a:t>using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R </a:t>
            </a:r>
            <a:r>
              <a:rPr lang="de-DE" sz="1200" dirty="0" err="1"/>
              <a:t>package</a:t>
            </a:r>
            <a:r>
              <a:rPr lang="de-DE" sz="1200" dirty="0"/>
              <a:t>: „irr“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42FBF2B1-23F3-CF1F-0525-74ED959CDF5C}"/>
              </a:ext>
            </a:extLst>
          </p:cNvPr>
          <p:cNvSpPr txBox="1"/>
          <p:nvPr/>
        </p:nvSpPr>
        <p:spPr>
          <a:xfrm>
            <a:off x="1747753" y="3597784"/>
            <a:ext cx="6100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b="1" dirty="0"/>
              <a:t>S3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9631747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7215" y="118037"/>
            <a:ext cx="3864785" cy="2733228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900" y="29508"/>
            <a:ext cx="4115140" cy="2910283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1010" y="58507"/>
            <a:ext cx="4031688" cy="2851265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26639" y="3085706"/>
            <a:ext cx="4176098" cy="2953393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978" y="3078506"/>
            <a:ext cx="4071771" cy="2996142"/>
          </a:xfrm>
          <a:prstGeom prst="rect">
            <a:avLst/>
          </a:prstGeom>
        </p:spPr>
      </p:pic>
      <p:sp>
        <p:nvSpPr>
          <p:cNvPr id="10" name="Rechteck 9"/>
          <p:cNvSpPr/>
          <p:nvPr/>
        </p:nvSpPr>
        <p:spPr>
          <a:xfrm>
            <a:off x="302156" y="2639284"/>
            <a:ext cx="60305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b="1" dirty="0"/>
              <a:t>S4 A</a:t>
            </a:r>
            <a:endParaRPr lang="de-DE" dirty="0"/>
          </a:p>
        </p:txBody>
      </p:sp>
      <p:sp>
        <p:nvSpPr>
          <p:cNvPr id="11" name="Rechteck 10"/>
          <p:cNvSpPr/>
          <p:nvPr/>
        </p:nvSpPr>
        <p:spPr>
          <a:xfrm>
            <a:off x="4408550" y="2311658"/>
            <a:ext cx="593432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endParaRPr lang="de-DE" b="1" dirty="0"/>
          </a:p>
          <a:p>
            <a:r>
              <a:rPr lang="de-DE" b="1" dirty="0"/>
              <a:t>S4 B</a:t>
            </a:r>
            <a:endParaRPr lang="de-DE" dirty="0"/>
          </a:p>
        </p:txBody>
      </p:sp>
      <p:sp>
        <p:nvSpPr>
          <p:cNvPr id="12" name="Rechteck 11"/>
          <p:cNvSpPr/>
          <p:nvPr/>
        </p:nvSpPr>
        <p:spPr>
          <a:xfrm>
            <a:off x="8327215" y="2586440"/>
            <a:ext cx="5854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b="1" dirty="0"/>
              <a:t>S4 C</a:t>
            </a:r>
            <a:endParaRPr lang="de-DE" dirty="0"/>
          </a:p>
        </p:txBody>
      </p:sp>
      <p:sp>
        <p:nvSpPr>
          <p:cNvPr id="13" name="Rechteck 12"/>
          <p:cNvSpPr/>
          <p:nvPr/>
        </p:nvSpPr>
        <p:spPr>
          <a:xfrm>
            <a:off x="171067" y="5758434"/>
            <a:ext cx="6069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b="1" dirty="0"/>
              <a:t>S4 D</a:t>
            </a:r>
            <a:endParaRPr lang="de-DE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0311" y="3106583"/>
            <a:ext cx="4031689" cy="2851265"/>
          </a:xfrm>
          <a:prstGeom prst="rect">
            <a:avLst/>
          </a:prstGeom>
        </p:spPr>
      </p:pic>
      <p:sp>
        <p:nvSpPr>
          <p:cNvPr id="4" name="Rechteck 3"/>
          <p:cNvSpPr/>
          <p:nvPr/>
        </p:nvSpPr>
        <p:spPr>
          <a:xfrm>
            <a:off x="4275210" y="5773182"/>
            <a:ext cx="5757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b="1" dirty="0"/>
              <a:t>S4 E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8378077" y="5690645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b="1" dirty="0"/>
              <a:t>S4 F</a:t>
            </a:r>
            <a:endParaRPr lang="de-DE" dirty="0"/>
          </a:p>
        </p:txBody>
      </p:sp>
      <p:sp>
        <p:nvSpPr>
          <p:cNvPr id="15" name="Rechteck 14"/>
          <p:cNvSpPr/>
          <p:nvPr/>
        </p:nvSpPr>
        <p:spPr>
          <a:xfrm>
            <a:off x="1932989" y="5865515"/>
            <a:ext cx="851127" cy="1846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4" name="Rechteck 13"/>
          <p:cNvSpPr/>
          <p:nvPr/>
        </p:nvSpPr>
        <p:spPr>
          <a:xfrm>
            <a:off x="1643490" y="5774828"/>
            <a:ext cx="1034257" cy="246221"/>
          </a:xfrm>
          <a:prstGeom prst="rect">
            <a:avLst/>
          </a:prstGeom>
        </p:spPr>
        <p:txBody>
          <a:bodyPr wrap="none" lIns="91440" tIns="45720" rIns="91440" bIns="45720" anchor="t">
            <a:spAutoFit/>
          </a:bodyPr>
          <a:lstStyle/>
          <a:p>
            <a:r>
              <a:rPr lang="en-US" sz="1000" b="1"/>
              <a:t>Th17 Tumor OS </a:t>
            </a:r>
            <a:endParaRPr lang="de-DE" sz="1000"/>
          </a:p>
        </p:txBody>
      </p:sp>
      <p:sp>
        <p:nvSpPr>
          <p:cNvPr id="16" name="Rechteck 15"/>
          <p:cNvSpPr/>
          <p:nvPr/>
        </p:nvSpPr>
        <p:spPr>
          <a:xfrm>
            <a:off x="5905062" y="5773182"/>
            <a:ext cx="995583" cy="2345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" name="Rechteck 16"/>
          <p:cNvSpPr/>
          <p:nvPr/>
        </p:nvSpPr>
        <p:spPr>
          <a:xfrm>
            <a:off x="5905062" y="5761503"/>
            <a:ext cx="1100271" cy="246221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1000" b="1" dirty="0"/>
              <a:t>Th17 Stroma OS </a:t>
            </a:r>
            <a:endParaRPr lang="de-DE" sz="1000" dirty="0"/>
          </a:p>
        </p:txBody>
      </p:sp>
      <p:sp>
        <p:nvSpPr>
          <p:cNvPr id="18" name="Rechteck 17"/>
          <p:cNvSpPr/>
          <p:nvPr/>
        </p:nvSpPr>
        <p:spPr>
          <a:xfrm>
            <a:off x="9939118" y="5721475"/>
            <a:ext cx="851127" cy="1846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b="1" dirty="0"/>
              <a:t>ROR</a:t>
            </a:r>
            <a:r>
              <a:rPr lang="de-DE" b="1" dirty="0" err="1"/>
              <a:t>γ</a:t>
            </a:r>
            <a:r>
              <a:rPr lang="en-US" b="1" dirty="0"/>
              <a:t>t+ Stroma </a:t>
            </a:r>
            <a:endParaRPr lang="de-DE" dirty="0"/>
          </a:p>
        </p:txBody>
      </p:sp>
      <p:sp>
        <p:nvSpPr>
          <p:cNvPr id="19" name="Rechteck 18"/>
          <p:cNvSpPr/>
          <p:nvPr/>
        </p:nvSpPr>
        <p:spPr>
          <a:xfrm>
            <a:off x="9863837" y="5721475"/>
            <a:ext cx="12506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/>
              <a:t>Th17 Overall Tissue </a:t>
            </a:r>
            <a:endParaRPr lang="de-DE" sz="1000" dirty="0"/>
          </a:p>
        </p:txBody>
      </p:sp>
      <p:sp>
        <p:nvSpPr>
          <p:cNvPr id="21" name="Rechteck 20"/>
          <p:cNvSpPr/>
          <p:nvPr/>
        </p:nvSpPr>
        <p:spPr>
          <a:xfrm>
            <a:off x="1760355" y="2697205"/>
            <a:ext cx="1115849" cy="1540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0" name="Rechteck 19"/>
          <p:cNvSpPr/>
          <p:nvPr/>
        </p:nvSpPr>
        <p:spPr>
          <a:xfrm>
            <a:off x="1760355" y="2665491"/>
            <a:ext cx="1003801" cy="246221"/>
          </a:xfrm>
          <a:prstGeom prst="rect">
            <a:avLst/>
          </a:prstGeom>
        </p:spPr>
        <p:txBody>
          <a:bodyPr wrap="none" lIns="91440" tIns="45720" rIns="91440" bIns="45720" anchor="t">
            <a:spAutoFit/>
          </a:bodyPr>
          <a:lstStyle/>
          <a:p>
            <a:r>
              <a:rPr lang="de-DE" sz="1000" b="1" err="1"/>
              <a:t>Treg</a:t>
            </a:r>
            <a:r>
              <a:rPr lang="de-DE" sz="1000" b="1"/>
              <a:t> </a:t>
            </a:r>
            <a:r>
              <a:rPr lang="en-US" sz="1000" b="1"/>
              <a:t>Tumor OS </a:t>
            </a:r>
            <a:endParaRPr lang="de-DE" sz="1000"/>
          </a:p>
        </p:txBody>
      </p:sp>
      <p:sp>
        <p:nvSpPr>
          <p:cNvPr id="22" name="Rechteck 21"/>
          <p:cNvSpPr/>
          <p:nvPr/>
        </p:nvSpPr>
        <p:spPr>
          <a:xfrm>
            <a:off x="5784796" y="2690647"/>
            <a:ext cx="1115849" cy="1540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3" name="Rechteck 22"/>
          <p:cNvSpPr/>
          <p:nvPr/>
        </p:nvSpPr>
        <p:spPr>
          <a:xfrm>
            <a:off x="9874466" y="2660801"/>
            <a:ext cx="1115849" cy="1540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4" name="Rechteck 23"/>
          <p:cNvSpPr/>
          <p:nvPr/>
        </p:nvSpPr>
        <p:spPr>
          <a:xfrm>
            <a:off x="5783373" y="2511714"/>
            <a:ext cx="1631408" cy="246221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r>
              <a:rPr lang="de-DE" sz="1000" b="1" err="1"/>
              <a:t>Treg</a:t>
            </a:r>
            <a:r>
              <a:rPr lang="de-DE" sz="1000" b="1"/>
              <a:t> Stroma OS</a:t>
            </a:r>
            <a:endParaRPr lang="de-DE" sz="1000" b="1">
              <a:cs typeface="Calibri"/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9863340" y="2578305"/>
            <a:ext cx="1377300" cy="246221"/>
          </a:xfrm>
          <a:prstGeom prst="rect">
            <a:avLst/>
          </a:prstGeom>
        </p:spPr>
        <p:txBody>
          <a:bodyPr wrap="none" lIns="91440" tIns="45720" rIns="91440" bIns="45720" anchor="t">
            <a:spAutoFit/>
          </a:bodyPr>
          <a:lstStyle/>
          <a:p>
            <a:r>
              <a:rPr lang="de-DE" sz="1000" b="1" err="1"/>
              <a:t>Treg</a:t>
            </a:r>
            <a:r>
              <a:rPr lang="de-DE" sz="1000" b="1"/>
              <a:t> </a:t>
            </a:r>
            <a:r>
              <a:rPr lang="en-US" sz="1000" b="1"/>
              <a:t>Overall tissue OS </a:t>
            </a:r>
            <a:endParaRPr lang="de-DE" sz="1000"/>
          </a:p>
        </p:txBody>
      </p:sp>
    </p:spTree>
    <p:extLst>
      <p:ext uri="{BB962C8B-B14F-4D97-AF65-F5344CB8AC3E}">
        <p14:creationId xmlns:p14="http://schemas.microsoft.com/office/powerpoint/2010/main" val="10903810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6">
            <a:extLst>
              <a:ext uri="{FF2B5EF4-FFF2-40B4-BE49-F238E27FC236}">
                <a16:creationId xmlns:a16="http://schemas.microsoft.com/office/drawing/2014/main" id="{C52FD046-69FB-43A7-98B0-66F176A5A5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4482" y="640208"/>
            <a:ext cx="3862873" cy="3859197"/>
          </a:xfrm>
          <a:prstGeom prst="rect">
            <a:avLst/>
          </a:prstGeom>
        </p:spPr>
      </p:pic>
      <p:sp>
        <p:nvSpPr>
          <p:cNvPr id="6" name="Rechteck 5">
            <a:extLst>
              <a:ext uri="{FF2B5EF4-FFF2-40B4-BE49-F238E27FC236}">
                <a16:creationId xmlns:a16="http://schemas.microsoft.com/office/drawing/2014/main" id="{A4ADCF57-8732-5F43-9EF0-0B93BA92CF90}"/>
              </a:ext>
            </a:extLst>
          </p:cNvPr>
          <p:cNvSpPr/>
          <p:nvPr/>
        </p:nvSpPr>
        <p:spPr>
          <a:xfrm>
            <a:off x="4207684" y="4466259"/>
            <a:ext cx="97738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b="1" dirty="0"/>
              <a:t>S5 B</a:t>
            </a:r>
            <a:endParaRPr lang="de-DE" dirty="0"/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9B5F6F67-94A7-F64B-8AAF-CB0CFC067966}"/>
              </a:ext>
            </a:extLst>
          </p:cNvPr>
          <p:cNvSpPr/>
          <p:nvPr/>
        </p:nvSpPr>
        <p:spPr>
          <a:xfrm>
            <a:off x="762094" y="4427381"/>
            <a:ext cx="60305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b="1" dirty="0"/>
              <a:t>S5 A</a:t>
            </a:r>
            <a:endParaRPr lang="de-DE" dirty="0"/>
          </a:p>
        </p:txBody>
      </p:sp>
      <p:sp>
        <p:nvSpPr>
          <p:cNvPr id="4" name="Rechteck 3"/>
          <p:cNvSpPr/>
          <p:nvPr/>
        </p:nvSpPr>
        <p:spPr>
          <a:xfrm>
            <a:off x="2448549" y="656162"/>
            <a:ext cx="2282529" cy="2493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127944" y="-1"/>
            <a:ext cx="4722351" cy="10564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b="1">
                <a:solidFill>
                  <a:schemeClr val="tx1"/>
                </a:solidFill>
              </a:rPr>
              <a:t>OS according </a:t>
            </a:r>
            <a:r>
              <a:rPr lang="de-DE" b="1" err="1">
                <a:solidFill>
                  <a:schemeClr val="tx1"/>
                </a:solidFill>
              </a:rPr>
              <a:t>to</a:t>
            </a:r>
            <a:r>
              <a:rPr lang="de-DE" b="1">
                <a:solidFill>
                  <a:schemeClr val="tx1"/>
                </a:solidFill>
              </a:rPr>
              <a:t> FOXP3 </a:t>
            </a:r>
            <a:r>
              <a:rPr lang="de-DE" b="1" err="1">
                <a:solidFill>
                  <a:schemeClr val="tx1"/>
                </a:solidFill>
              </a:rPr>
              <a:t>expression</a:t>
            </a:r>
            <a:endParaRPr lang="de-DE" b="1">
              <a:solidFill>
                <a:schemeClr val="tx1"/>
              </a:solidFill>
            </a:endParaRPr>
          </a:p>
          <a:p>
            <a:pPr algn="ctr"/>
            <a:r>
              <a:rPr lang="de-DE" b="1">
                <a:solidFill>
                  <a:schemeClr val="tx1"/>
                </a:solidFill>
              </a:rPr>
              <a:t> (FIGO III/IV)</a:t>
            </a:r>
          </a:p>
        </p:txBody>
      </p:sp>
      <p:sp>
        <p:nvSpPr>
          <p:cNvPr id="8" name="Rechteck 7"/>
          <p:cNvSpPr/>
          <p:nvPr/>
        </p:nvSpPr>
        <p:spPr>
          <a:xfrm>
            <a:off x="4207684" y="531471"/>
            <a:ext cx="3799643" cy="2493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b="1">
                <a:solidFill>
                  <a:schemeClr val="tx1"/>
                </a:solidFill>
              </a:rPr>
              <a:t>OS according to RORC expression  </a:t>
            </a:r>
          </a:p>
        </p:txBody>
      </p:sp>
      <p:sp>
        <p:nvSpPr>
          <p:cNvPr id="15" name="Rechteck 14"/>
          <p:cNvSpPr/>
          <p:nvPr/>
        </p:nvSpPr>
        <p:spPr>
          <a:xfrm>
            <a:off x="8369729" y="452964"/>
            <a:ext cx="34455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b="1"/>
              <a:t>OS according </a:t>
            </a:r>
            <a:r>
              <a:rPr lang="de-DE" b="1" err="1"/>
              <a:t>to</a:t>
            </a:r>
            <a:r>
              <a:rPr lang="de-DE" b="1"/>
              <a:t> RORC:FOXP3 </a:t>
            </a:r>
            <a:r>
              <a:rPr lang="de-DE" b="1" err="1"/>
              <a:t>ratio</a:t>
            </a:r>
            <a:endParaRPr lang="de-DE" b="1"/>
          </a:p>
        </p:txBody>
      </p:sp>
      <p:sp>
        <p:nvSpPr>
          <p:cNvPr id="16" name="Rechteck 15">
            <a:extLst>
              <a:ext uri="{FF2B5EF4-FFF2-40B4-BE49-F238E27FC236}">
                <a16:creationId xmlns:a16="http://schemas.microsoft.com/office/drawing/2014/main" id="{A4ADCF57-8732-5F43-9EF0-0B93BA92CF90}"/>
              </a:ext>
            </a:extLst>
          </p:cNvPr>
          <p:cNvSpPr/>
          <p:nvPr/>
        </p:nvSpPr>
        <p:spPr>
          <a:xfrm>
            <a:off x="8070507" y="4427927"/>
            <a:ext cx="72020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b="1" dirty="0"/>
              <a:t>S5 C</a:t>
            </a:r>
            <a:endParaRPr lang="de-DE" dirty="0"/>
          </a:p>
        </p:txBody>
      </p:sp>
      <p:pic>
        <p:nvPicPr>
          <p:cNvPr id="1026" name="Picture 2" descr="https://kmplot.com/analysis/Rout/km_210911_140802_956000_meanprobe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92755" y="475369"/>
            <a:ext cx="3791541" cy="37915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https://kmplot.com/analysis/Rout/km_210911_141632_301300_228806_at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1121" y="573716"/>
            <a:ext cx="3939234" cy="39392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Rechteck 16"/>
          <p:cNvSpPr/>
          <p:nvPr/>
        </p:nvSpPr>
        <p:spPr>
          <a:xfrm>
            <a:off x="4564096" y="193355"/>
            <a:ext cx="3766969" cy="68877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b="1">
                <a:solidFill>
                  <a:schemeClr val="tx1"/>
                </a:solidFill>
              </a:rPr>
              <a:t>OS according </a:t>
            </a:r>
            <a:r>
              <a:rPr lang="de-DE" b="1" err="1">
                <a:solidFill>
                  <a:schemeClr val="tx1"/>
                </a:solidFill>
              </a:rPr>
              <a:t>to</a:t>
            </a:r>
            <a:r>
              <a:rPr lang="de-DE" b="1">
                <a:solidFill>
                  <a:schemeClr val="tx1"/>
                </a:solidFill>
              </a:rPr>
              <a:t> RORC </a:t>
            </a:r>
            <a:r>
              <a:rPr lang="de-DE" b="1" err="1">
                <a:solidFill>
                  <a:schemeClr val="tx1"/>
                </a:solidFill>
              </a:rPr>
              <a:t>expression</a:t>
            </a:r>
            <a:endParaRPr lang="de-DE" b="1">
              <a:solidFill>
                <a:schemeClr val="tx1"/>
              </a:solidFill>
            </a:endParaRPr>
          </a:p>
          <a:p>
            <a:pPr algn="ctr"/>
            <a:r>
              <a:rPr lang="de-DE" b="1">
                <a:solidFill>
                  <a:schemeClr val="tx1"/>
                </a:solidFill>
              </a:rPr>
              <a:t> (FIGO III/IV)</a:t>
            </a:r>
          </a:p>
        </p:txBody>
      </p:sp>
      <p:sp>
        <p:nvSpPr>
          <p:cNvPr id="18" name="Rechteck 17"/>
          <p:cNvSpPr/>
          <p:nvPr/>
        </p:nvSpPr>
        <p:spPr>
          <a:xfrm>
            <a:off x="8283037" y="130982"/>
            <a:ext cx="3874929" cy="68877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b="1">
                <a:solidFill>
                  <a:schemeClr val="tx1"/>
                </a:solidFill>
              </a:rPr>
              <a:t>OS according </a:t>
            </a:r>
            <a:r>
              <a:rPr lang="de-DE" b="1" err="1">
                <a:solidFill>
                  <a:schemeClr val="tx1"/>
                </a:solidFill>
              </a:rPr>
              <a:t>to</a:t>
            </a:r>
            <a:r>
              <a:rPr lang="de-DE" b="1">
                <a:solidFill>
                  <a:schemeClr val="tx1"/>
                </a:solidFill>
              </a:rPr>
              <a:t> RORC:FOXP3 </a:t>
            </a:r>
            <a:r>
              <a:rPr lang="de-DE" b="1" err="1">
                <a:solidFill>
                  <a:schemeClr val="tx1"/>
                </a:solidFill>
              </a:rPr>
              <a:t>expression</a:t>
            </a:r>
            <a:r>
              <a:rPr lang="de-DE" b="1">
                <a:solidFill>
                  <a:schemeClr val="tx1"/>
                </a:solidFill>
              </a:rPr>
              <a:t> (FIGO III/IV)</a:t>
            </a:r>
          </a:p>
        </p:txBody>
      </p:sp>
    </p:spTree>
    <p:extLst>
      <p:ext uri="{BB962C8B-B14F-4D97-AF65-F5344CB8AC3E}">
        <p14:creationId xmlns:p14="http://schemas.microsoft.com/office/powerpoint/2010/main" val="28751010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0</Words>
  <Application>Microsoft Macintosh PowerPoint</Application>
  <PresentationFormat>Breitbild</PresentationFormat>
  <Paragraphs>50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Courier New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1Gn1PERFJZFIHV6p</dc:creator>
  <cp:lastModifiedBy>1Gn1PERFJZFIHV6p</cp:lastModifiedBy>
  <cp:revision>4</cp:revision>
  <dcterms:created xsi:type="dcterms:W3CDTF">2022-03-12T13:29:59Z</dcterms:created>
  <dcterms:modified xsi:type="dcterms:W3CDTF">2022-05-27T22:28:17Z</dcterms:modified>
</cp:coreProperties>
</file>